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1.png" ContentType="image/png"/>
  <Override PartName="/ppt/media/image14.png" ContentType="image/png"/>
  <Override PartName="/ppt/media/image9.png" ContentType="image/png"/>
  <Override PartName="/ppt/media/image1.png" ContentType="image/png"/>
  <Override PartName="/ppt/media/image3.jpeg" ContentType="image/jpeg"/>
  <Override PartName="/ppt/media/image2.png" ContentType="image/png"/>
  <Override PartName="/ppt/media/image4.jpeg" ContentType="image/jpeg"/>
  <Override PartName="/ppt/media/image5.jpeg" ContentType="image/jpeg"/>
  <Override PartName="/ppt/media/image8.png" ContentType="image/png"/>
  <Override PartName="/ppt/media/image13.png" ContentType="image/png"/>
  <Override PartName="/ppt/media/image7.png" ContentType="image/png"/>
  <Override PartName="/ppt/media/image12.png" ContentType="image/png"/>
  <Override PartName="/ppt/media/image6.jpeg" ContentType="image/jpeg"/>
  <Override PartName="/ppt/media/image10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41291D-4E04-4B53-9B0F-A367AC4A06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445F0C-9EFD-4B4F-B04F-09FBB44D9F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047C6-26DF-4E18-B74F-0953C5907B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BC130-CF1D-4629-818B-53D9F5F8E6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F36A14-C1D1-409F-A5D5-F3EB7804D9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19C63AF-DE71-4509-8AC6-9AFC050934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9A08747-B718-4A86-81DC-F0114B2565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6CF7047-516F-4525-AAAE-763DE30C64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341DC28-754C-4017-8DF8-7C0798DC91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528B1B2-575A-4421-97BA-F88EE93711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838F32D-8499-43F2-B191-9EC07280AF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38D494-F455-4D2D-BD8F-B42EA2150F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1BA3506-C32C-464C-AF9E-D397E973BF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4B9DF64-6014-4BFC-82D6-5DE373901F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2B586D7-DFCC-4BA7-BD93-C155411C4C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751BE28-3F0C-4D3C-9C65-06B5B84FE4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267B93B-9A27-4382-9748-C902C673D4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D7BAC2-6FAA-460F-8FAD-935F18405B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ED6F1-6FDF-4340-9207-A10935B7B5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30348-6A0A-40EA-96C3-09C667FB55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B11E5-AA3A-409A-9A2D-857194E69E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4D333-47BE-42BA-BCE4-FCF49FBC10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4E7DA-9145-4B84-B23D-C67E4EE9AC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2B38C-0921-4016-AB8C-D54590F4E3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A5DC16-C2FD-421C-B7ED-385D1A332787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6" descr="swoosh_va.tif"/>
          <p:cNvPicPr/>
          <p:nvPr/>
        </p:nvPicPr>
        <p:blipFill>
          <a:blip r:embed="rId2"/>
          <a:stretch/>
        </p:blipFill>
        <p:spPr>
          <a:xfrm>
            <a:off x="0" y="5286240"/>
            <a:ext cx="9144000" cy="1735200"/>
          </a:xfrm>
          <a:prstGeom prst="rect">
            <a:avLst/>
          </a:prstGeom>
          <a:ln w="0">
            <a:noFill/>
          </a:ln>
        </p:spPr>
      </p:pic>
      <p:pic>
        <p:nvPicPr>
          <p:cNvPr id="42" name="Grafik 7" descr="logo.tif"/>
          <p:cNvPicPr/>
          <p:nvPr/>
        </p:nvPicPr>
        <p:blipFill>
          <a:blip r:embed="rId3"/>
          <a:stretch/>
        </p:blipFill>
        <p:spPr>
          <a:xfrm>
            <a:off x="5214960" y="6072120"/>
            <a:ext cx="3749760" cy="592200"/>
          </a:xfrm>
          <a:prstGeom prst="rect">
            <a:avLst/>
          </a:prstGeom>
          <a:ln w="0">
            <a:noFill/>
          </a:ln>
        </p:spPr>
      </p:pic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096829-EF46-4C0A-AD23-DBEC5A523BDC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Rectangle 2"/>
          <p:cNvSpPr/>
          <p:nvPr/>
        </p:nvSpPr>
        <p:spPr>
          <a:xfrm>
            <a:off x="395280" y="287280"/>
            <a:ext cx="8255160" cy="80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Calibri"/>
              </a:rPr>
              <a:t>Volkskrankheit Nummer Eins: Bluthochdruck</a:t>
            </a:r>
            <a:br>
              <a:rPr sz="2800"/>
            </a:b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- Hauptrisikofaktor für Herzinfarkte und Schlaganfäll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hteck 9"/>
          <p:cNvSpPr/>
          <p:nvPr/>
        </p:nvSpPr>
        <p:spPr>
          <a:xfrm>
            <a:off x="395280" y="1413000"/>
            <a:ext cx="8569440" cy="61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Mehr als ein Drittel der Deutschen leidet unter Bluthochdruck. </a:t>
            </a:r>
            <a:br>
              <a:rPr sz="1700"/>
            </a:b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Das sind etwa 25 Millionen Menschen. 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hteck 10"/>
          <p:cNvSpPr/>
          <p:nvPr/>
        </p:nvSpPr>
        <p:spPr>
          <a:xfrm>
            <a:off x="395280" y="2260440"/>
            <a:ext cx="6391440" cy="61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Bluthochdruck schädigt die Gefäße und führt </a:t>
            </a:r>
            <a:br>
              <a:rPr sz="1700"/>
            </a:b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zu Arteriosklerose. 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hteck 7"/>
          <p:cNvSpPr/>
          <p:nvPr/>
        </p:nvSpPr>
        <p:spPr>
          <a:xfrm>
            <a:off x="539640" y="3693960"/>
            <a:ext cx="638964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Herzinfarkte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hteck 13"/>
          <p:cNvSpPr/>
          <p:nvPr/>
        </p:nvSpPr>
        <p:spPr>
          <a:xfrm>
            <a:off x="539640" y="4460760"/>
            <a:ext cx="638964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Schäden an Augen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hteck 14"/>
          <p:cNvSpPr/>
          <p:nvPr/>
        </p:nvSpPr>
        <p:spPr>
          <a:xfrm>
            <a:off x="539640" y="4078440"/>
            <a:ext cx="638964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Schlaganfälle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hteck 15"/>
          <p:cNvSpPr/>
          <p:nvPr/>
        </p:nvSpPr>
        <p:spPr>
          <a:xfrm>
            <a:off x="539640" y="4844880"/>
            <a:ext cx="638964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Schäden an Nieren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hteck 16"/>
          <p:cNvSpPr/>
          <p:nvPr/>
        </p:nvSpPr>
        <p:spPr>
          <a:xfrm>
            <a:off x="395280" y="3273480"/>
            <a:ext cx="639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Das Risiko für folgende Krankheiten erhöht sich drastisch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: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hteck 12"/>
          <p:cNvSpPr/>
          <p:nvPr/>
        </p:nvSpPr>
        <p:spPr>
          <a:xfrm>
            <a:off x="737280" y="6597720"/>
            <a:ext cx="1697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ffffff"/>
                </a:solidFill>
                <a:latin typeface="Calibri"/>
                <a:ea typeface="Arial"/>
              </a:rPr>
              <a:t>* Quelle: www.gbe-bund.d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Grafik 25" descr="BHD-Grafik.jpg"/>
          <p:cNvPicPr/>
          <p:nvPr/>
        </p:nvPicPr>
        <p:blipFill>
          <a:blip r:embed="rId1"/>
          <a:stretch/>
        </p:blipFill>
        <p:spPr>
          <a:xfrm>
            <a:off x="6215040" y="1357200"/>
            <a:ext cx="2793960" cy="3959280"/>
          </a:xfrm>
          <a:prstGeom prst="rect">
            <a:avLst/>
          </a:prstGeom>
          <a:ln w="0">
            <a:noFill/>
          </a:ln>
        </p:spPr>
      </p:pic>
    </p:spTree>
  </p:cSld>
  <p:transition spd="slow" advTm="29000">
    <p:wipe dir="l"/>
  </p:transition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0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afterEffect" fill="hold" presetClass="entr" presetID="2" presetSubtype="4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2000" fill="hold"/>
                                        <p:tgtEl>
                                          <p:spTgt spid="8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2000" fill="hold"/>
                                        <p:tgtEl>
                                          <p:spTgt spid="8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" nodeType="afterEffect" fill="hold">
                            <p:stCondLst>
                              <p:cond delay="4000"/>
                            </p:stCondLst>
                            <p:childTnLst>
                              <p:par>
                                <p:cTn id="10" nodeType="afterEffect" fill="hold" presetClass="entr" presetID="3" presetSubtype="10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12" dur="1000"/>
                                        <p:tgtEl>
                                          <p:spTgt spid="9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nodeType="afterEffect" fill="hold">
                            <p:stCondLst>
                              <p:cond delay="6000"/>
                            </p:stCondLst>
                            <p:childTnLst>
                              <p:par>
                                <p:cTn id="14" nodeType="afterEffect" fill="hold" presetClass="entr" presetID="2" presetSubtype="4">
                                  <p:stCondLst>
                                    <p:cond delay="400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2000" fill="hold"/>
                                        <p:tgtEl>
                                          <p:spTgt spid="8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2000" fill="hold"/>
                                        <p:tgtEl>
                                          <p:spTgt spid="8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" nodeType="afterEffect" fill="hold">
                            <p:stCondLst>
                              <p:cond delay="12000"/>
                            </p:stCondLst>
                            <p:childTnLst>
                              <p:par>
                                <p:cTn id="19" nodeType="afterEffect" fill="hold" presetClass="entr" presetID="2" presetSubtype="4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1" dur="2000" fill="hold"/>
                                        <p:tgtEl>
                                          <p:spTgt spid="9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2" dur="2000" fill="hold"/>
                                        <p:tgtEl>
                                          <p:spTgt spid="9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3" nodeType="afterEffect" fill="hold">
                            <p:stCondLst>
                              <p:cond delay="16000"/>
                            </p:stCondLst>
                            <p:childTnLst>
                              <p:par>
                                <p:cTn id="24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6" dur="2000" fill="hold"/>
                                        <p:tgtEl>
                                          <p:spTgt spid="8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7" dur="2000" fill="hold"/>
                                        <p:tgtEl>
                                          <p:spTgt spid="8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8" nodeType="afterEffect" fill="hold">
                            <p:stCondLst>
                              <p:cond delay="18500"/>
                            </p:stCondLst>
                            <p:childTnLst>
                              <p:par>
                                <p:cTn id="29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2000" fill="hold"/>
                                        <p:tgtEl>
                                          <p:spTgt spid="8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2000" fill="hold"/>
                                        <p:tgtEl>
                                          <p:spTgt spid="8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3" nodeType="afterEffect" fill="hold">
                            <p:stCondLst>
                              <p:cond delay="20500"/>
                            </p:stCondLst>
                            <p:childTnLst>
                              <p:par>
                                <p:cTn id="34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6" dur="2000" fill="hold"/>
                                        <p:tgtEl>
                                          <p:spTgt spid="8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7" dur="2000" fill="hold"/>
                                        <p:tgtEl>
                                          <p:spTgt spid="8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nodeType="afterEffect" fill="hold">
                            <p:stCondLst>
                              <p:cond delay="22500"/>
                            </p:stCondLst>
                            <p:childTnLst>
                              <p:par>
                                <p:cTn id="39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1" dur="2000" fill="hold"/>
                                        <p:tgtEl>
                                          <p:spTgt spid="9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2" dur="2000" fill="hold"/>
                                        <p:tgtEl>
                                          <p:spTgt spid="9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Rectangle 2"/>
          <p:cNvSpPr/>
          <p:nvPr/>
        </p:nvSpPr>
        <p:spPr>
          <a:xfrm>
            <a:off x="395280" y="287280"/>
            <a:ext cx="8255160" cy="80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Calibri"/>
              </a:rPr>
              <a:t>9 Millionen Betroffene: Volkskrankheit Diabetes</a:t>
            </a:r>
            <a:br>
              <a:rPr sz="2800"/>
            </a:b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- Gefahr für Füße, Augen, Nerven und Niere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hteck 9"/>
          <p:cNvSpPr/>
          <p:nvPr/>
        </p:nvSpPr>
        <p:spPr>
          <a:xfrm>
            <a:off x="395280" y="1415880"/>
            <a:ext cx="849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Expertenschätzung zufolge wird sich die Zahl der Diabeteskranken bis 2020 verdoppeln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hteck 12"/>
          <p:cNvSpPr/>
          <p:nvPr/>
        </p:nvSpPr>
        <p:spPr>
          <a:xfrm>
            <a:off x="395280" y="1978200"/>
            <a:ext cx="46083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Erhöhte Blutzuckerwerte verursachen häufig </a:t>
            </a:r>
            <a:br>
              <a:rPr sz="1800"/>
            </a:b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keine Beschwerden, so dass viele Betroffene </a:t>
            </a:r>
            <a:br>
              <a:rPr sz="1800"/>
            </a:b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von ihrer Erkrankung nichts bemerken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hteck 10"/>
          <p:cNvSpPr/>
          <p:nvPr/>
        </p:nvSpPr>
        <p:spPr>
          <a:xfrm>
            <a:off x="395280" y="3133800"/>
            <a:ext cx="4572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Folgeerkrankungen von Diabetes sind </a:t>
            </a:r>
            <a:br>
              <a:rPr sz="1800"/>
            </a:b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schwere Schädigungen an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hteck 13"/>
          <p:cNvSpPr/>
          <p:nvPr/>
        </p:nvSpPr>
        <p:spPr>
          <a:xfrm>
            <a:off x="563400" y="3905280"/>
            <a:ext cx="107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80b5"/>
                </a:solidFill>
                <a:latin typeface="TheSansBold-Plain"/>
                <a:ea typeface="Arial"/>
              </a:rPr>
              <a:t>&gt; 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Füß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hteck 14"/>
          <p:cNvSpPr/>
          <p:nvPr/>
        </p:nvSpPr>
        <p:spPr>
          <a:xfrm>
            <a:off x="377280" y="4313160"/>
            <a:ext cx="1319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80b5"/>
                </a:solidFill>
                <a:latin typeface="TheSansBold-Plain"/>
                <a:ea typeface="Arial"/>
              </a:rPr>
              <a:t>&gt; 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Aug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hteck 15"/>
          <p:cNvSpPr/>
          <p:nvPr/>
        </p:nvSpPr>
        <p:spPr>
          <a:xfrm>
            <a:off x="378720" y="4722840"/>
            <a:ext cx="1402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80b5"/>
                </a:solidFill>
                <a:latin typeface="TheSansBold-Plain"/>
                <a:ea typeface="Arial"/>
              </a:rPr>
              <a:t>&gt; 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Nerv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hteck 16"/>
          <p:cNvSpPr/>
          <p:nvPr/>
        </p:nvSpPr>
        <p:spPr>
          <a:xfrm>
            <a:off x="377640" y="5130720"/>
            <a:ext cx="135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80b5"/>
                </a:solidFill>
                <a:latin typeface="TheSansBold-Plain"/>
                <a:ea typeface="Arial"/>
              </a:rPr>
              <a:t>&gt; 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Nier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Grafik 17" descr="DIA-Grafik.jpg"/>
          <p:cNvPicPr/>
          <p:nvPr/>
        </p:nvPicPr>
        <p:blipFill>
          <a:blip r:embed="rId1"/>
          <a:stretch/>
        </p:blipFill>
        <p:spPr>
          <a:xfrm>
            <a:off x="5000760" y="2071800"/>
            <a:ext cx="4035240" cy="3240000"/>
          </a:xfrm>
          <a:prstGeom prst="rect">
            <a:avLst/>
          </a:prstGeom>
          <a:ln w="0">
            <a:noFill/>
          </a:ln>
        </p:spPr>
      </p:pic>
      <p:sp>
        <p:nvSpPr>
          <p:cNvPr id="103" name="Rechteck 18"/>
          <p:cNvSpPr/>
          <p:nvPr/>
        </p:nvSpPr>
        <p:spPr>
          <a:xfrm>
            <a:off x="737280" y="6597720"/>
            <a:ext cx="1697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ffffff"/>
                </a:solidFill>
                <a:latin typeface="Calibri"/>
                <a:ea typeface="Arial"/>
              </a:rPr>
              <a:t>* Quelle: www.gbe-bund.d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 advTm="30000">
    <p:wipe dir="l"/>
  </p:transition>
  <p:timing>
    <p:tnLst>
      <p:par>
        <p:cTn id="43" dur="indefinite" restart="never" nodeType="tmRoot">
          <p:childTnLst>
            <p:seq>
              <p:cTn id="44" dur="indefinite" nodeType="mainSeq">
                <p:childTnLst>
                  <p:par>
                    <p:cTn id="45" nodeType="clickEffect" fill="hold">
                      <p:stCondLst>
                        <p:cond delay="0"/>
                      </p:stCondLst>
                      <p:childTnLst>
                        <p:par>
                          <p:cTn id="46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47" nodeType="afterEffect" fill="hold" presetClass="entr" presetID="2" presetSubtype="4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9" dur="2000" fill="hold"/>
                                        <p:tgtEl>
                                          <p:spTgt spid="9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0" dur="2000" fill="hold"/>
                                        <p:tgtEl>
                                          <p:spTgt spid="9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1" nodeType="afterEffect" fill="hold">
                            <p:stCondLst>
                              <p:cond delay="4000"/>
                            </p:stCondLst>
                            <p:childTnLst>
                              <p:par>
                                <p:cTn id="52" nodeType="afterEffect" fill="hold" presetClass="entr" presetID="3" presetSubtype="10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54" dur="2000"/>
                                        <p:tgtEl>
                                          <p:spTgt spid="10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5" nodeType="afterEffect" fill="hold">
                            <p:stCondLst>
                              <p:cond delay="7000"/>
                            </p:stCondLst>
                            <p:childTnLst>
                              <p:par>
                                <p:cTn id="56" nodeType="afterEffect" fill="hold" presetClass="entr" presetID="2" presetSubtype="4">
                                  <p:stCondLst>
                                    <p:cond delay="4000"/>
                                  </p:stCondLst>
                                  <p:childTnLst>
                                    <p:set>
                                      <p:cBhvr>
                                        <p:cTn id="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8" dur="2000" fill="hold"/>
                                        <p:tgtEl>
                                          <p:spTgt spid="9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9" dur="2000" fill="hold"/>
                                        <p:tgtEl>
                                          <p:spTgt spid="9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0" nodeType="afterEffect" fill="hold">
                            <p:stCondLst>
                              <p:cond delay="13000"/>
                            </p:stCondLst>
                            <p:childTnLst>
                              <p:par>
                                <p:cTn id="61" nodeType="afterEffect" fill="hold" presetClass="entr" presetID="2" presetSubtype="4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3" dur="2000" fill="hold"/>
                                        <p:tgtEl>
                                          <p:spTgt spid="9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4" dur="2000" fill="hold"/>
                                        <p:tgtEl>
                                          <p:spTgt spid="9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5" nodeType="afterEffect" fill="hold">
                            <p:stCondLst>
                              <p:cond delay="17000"/>
                            </p:stCondLst>
                            <p:childTnLst>
                              <p:par>
                                <p:cTn id="66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6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8" dur="2000" fill="hold"/>
                                        <p:tgtEl>
                                          <p:spTgt spid="9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9" dur="2000" fill="hold"/>
                                        <p:tgtEl>
                                          <p:spTgt spid="9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0" nodeType="afterEffect" fill="hold">
                            <p:stCondLst>
                              <p:cond delay="19500"/>
                            </p:stCondLst>
                            <p:childTnLst>
                              <p:par>
                                <p:cTn id="71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3" dur="2000" fill="hold"/>
                                        <p:tgtEl>
                                          <p:spTgt spid="9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74" dur="2000" fill="hold"/>
                                        <p:tgtEl>
                                          <p:spTgt spid="9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5" nodeType="afterEffect" fill="hold">
                            <p:stCondLst>
                              <p:cond delay="21500"/>
                            </p:stCondLst>
                            <p:childTnLst>
                              <p:par>
                                <p:cTn id="76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8" dur="2000" fill="hold"/>
                                        <p:tgtEl>
                                          <p:spTgt spid="10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79" dur="2000" fill="hold"/>
                                        <p:tgtEl>
                                          <p:spTgt spid="10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0" nodeType="afterEffect" fill="hold">
                            <p:stCondLst>
                              <p:cond delay="23500"/>
                            </p:stCondLst>
                            <p:childTnLst>
                              <p:par>
                                <p:cTn id="81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83" dur="2000" fill="hold"/>
                                        <p:tgtEl>
                                          <p:spTgt spid="10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4" dur="2000" fill="hold"/>
                                        <p:tgtEl>
                                          <p:spTgt spid="10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Rechteck 12"/>
          <p:cNvSpPr/>
          <p:nvPr/>
        </p:nvSpPr>
        <p:spPr>
          <a:xfrm>
            <a:off x="522360" y="1706400"/>
            <a:ext cx="619272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Rauchen Sie?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hteck 13"/>
          <p:cNvSpPr/>
          <p:nvPr/>
        </p:nvSpPr>
        <p:spPr>
          <a:xfrm>
            <a:off x="522360" y="1096920"/>
            <a:ext cx="619272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Haben Sie Übergewicht?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hteck 14"/>
          <p:cNvSpPr/>
          <p:nvPr/>
        </p:nvSpPr>
        <p:spPr>
          <a:xfrm>
            <a:off x="522360" y="2316240"/>
            <a:ext cx="619272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Haben Sie viel Stress? 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hteck 15"/>
          <p:cNvSpPr/>
          <p:nvPr/>
        </p:nvSpPr>
        <p:spPr>
          <a:xfrm>
            <a:off x="522360" y="2924280"/>
            <a:ext cx="6192720" cy="61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Betätigen Sie sich weniger </a:t>
            </a:r>
            <a:br>
              <a:rPr sz="1700"/>
            </a:b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als 30 Minuten am Tag körperlich?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hteck 16"/>
          <p:cNvSpPr/>
          <p:nvPr/>
        </p:nvSpPr>
        <p:spPr>
          <a:xfrm>
            <a:off x="522360" y="3811680"/>
            <a:ext cx="6192720" cy="61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Haben Sie Verwandte mit </a:t>
            </a:r>
            <a:br>
              <a:rPr sz="1700"/>
            </a:b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Herz-Kreislauf-Erkrankungen oder Diabetes?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hteck 17"/>
          <p:cNvSpPr/>
          <p:nvPr/>
        </p:nvSpPr>
        <p:spPr>
          <a:xfrm>
            <a:off x="522360" y="4697280"/>
            <a:ext cx="4572000" cy="61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6040" indent="-1760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700" spc="-1" strike="noStrike">
                <a:solidFill>
                  <a:srgbClr val="0080b5"/>
                </a:solidFill>
                <a:latin typeface="TheSansBold-Plain"/>
              </a:rPr>
              <a:t>&gt; </a:t>
            </a: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Essen Sie weniger als einmal täglich Obst, </a:t>
            </a:r>
            <a:br>
              <a:rPr sz="1700"/>
            </a:br>
            <a:r>
              <a:rPr b="0" lang="de-DE" sz="1700" spc="-1" strike="noStrike">
                <a:solidFill>
                  <a:srgbClr val="000000"/>
                </a:solidFill>
                <a:latin typeface="Calibri"/>
              </a:rPr>
              <a:t>Gemüse oder dunkles Brot?</a:t>
            </a:r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"/>
          <p:cNvSpPr/>
          <p:nvPr/>
        </p:nvSpPr>
        <p:spPr>
          <a:xfrm>
            <a:off x="395280" y="287280"/>
            <a:ext cx="8255160" cy="80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Calibri"/>
              </a:rPr>
              <a:t>Wie hoch ist Ihr Risiko?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Grafik 11" descr="Untitled-2.jpg"/>
          <p:cNvPicPr/>
          <p:nvPr/>
        </p:nvPicPr>
        <p:blipFill>
          <a:blip r:embed="rId1"/>
          <a:stretch/>
        </p:blipFill>
        <p:spPr>
          <a:xfrm>
            <a:off x="5000760" y="500040"/>
            <a:ext cx="3881160" cy="4857840"/>
          </a:xfrm>
          <a:prstGeom prst="rect">
            <a:avLst/>
          </a:prstGeom>
          <a:ln w="0">
            <a:noFill/>
          </a:ln>
        </p:spPr>
      </p:pic>
    </p:spTree>
  </p:cSld>
  <p:transition spd="slow" advTm="22000">
    <p:wipe dir="l"/>
  </p:transition>
  <p:timing>
    <p:tnLst>
      <p:par>
        <p:cTn id="85" dur="indefinite" restart="never" nodeType="tmRoot">
          <p:childTnLst>
            <p:seq>
              <p:cTn id="86" dur="indefinite" nodeType="mainSeq">
                <p:childTnLst>
                  <p:par>
                    <p:cTn id="87" nodeType="clickEffect" fill="hold">
                      <p:stCondLst>
                        <p:cond delay="0"/>
                      </p:stCondLst>
                      <p:childTnLst>
                        <p:par>
                          <p:cTn id="88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89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91" dur="2000" fill="hold"/>
                                        <p:tgtEl>
                                          <p:spTgt spid="10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92" dur="2000" fill="hold"/>
                                        <p:tgtEl>
                                          <p:spTgt spid="10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3" nodeType="afterEffect" fill="hold">
                            <p:stCondLst>
                              <p:cond delay="2500"/>
                            </p:stCondLst>
                            <p:childTnLst>
                              <p:par>
                                <p:cTn id="94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96" dur="2000" fill="hold"/>
                                        <p:tgtEl>
                                          <p:spTgt spid="10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97" dur="2000" fill="hold"/>
                                        <p:tgtEl>
                                          <p:spTgt spid="10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8" nodeType="afterEffect" fill="hold">
                            <p:stCondLst>
                              <p:cond delay="5000"/>
                            </p:stCondLst>
                            <p:childTnLst>
                              <p:par>
                                <p:cTn id="99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1" dur="20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02" dur="20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3" nodeType="afterEffect" fill="hold">
                            <p:stCondLst>
                              <p:cond delay="7500"/>
                            </p:stCondLst>
                            <p:childTnLst>
                              <p:par>
                                <p:cTn id="104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0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6" dur="2000" fill="hold"/>
                                        <p:tgtEl>
                                          <p:spTgt spid="10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07" dur="2000" fill="hold"/>
                                        <p:tgtEl>
                                          <p:spTgt spid="10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8" nodeType="afterEffect" fill="hold">
                            <p:stCondLst>
                              <p:cond delay="10000"/>
                            </p:stCondLst>
                            <p:childTnLst>
                              <p:par>
                                <p:cTn id="109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1" dur="2000" fill="hold"/>
                                        <p:tgtEl>
                                          <p:spTgt spid="10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2" dur="2000" fill="hold"/>
                                        <p:tgtEl>
                                          <p:spTgt spid="10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3" nodeType="afterEffect" fill="hold">
                            <p:stCondLst>
                              <p:cond delay="12500"/>
                            </p:stCondLst>
                            <p:childTnLst>
                              <p:par>
                                <p:cTn id="114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6" dur="2000" fill="hold"/>
                                        <p:tgtEl>
                                          <p:spTgt spid="10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7" dur="2000" fill="hold"/>
                                        <p:tgtEl>
                                          <p:spTgt spid="10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8" nodeType="afterEffect" fill="hold">
                            <p:stCondLst>
                              <p:cond delay="15000"/>
                            </p:stCondLst>
                            <p:childTnLst>
                              <p:par>
                                <p:cTn id="119" nodeType="afterEffect" fill="hold" presetClass="entr" presetID="3" presetSubtype="10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121" dur="1000"/>
                                        <p:tgtEl>
                                          <p:spTgt spid="1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Rectangle 2"/>
          <p:cNvSpPr/>
          <p:nvPr/>
        </p:nvSpPr>
        <p:spPr>
          <a:xfrm>
            <a:off x="395280" y="596880"/>
            <a:ext cx="825516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>
              <a:lnSpc>
                <a:spcPct val="100000"/>
              </a:lnSpc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Calibri"/>
              </a:rPr>
              <a:t>Schon kleine Veränderungen der Gewohnheiten senken Ihre Risiken erheblich!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hteck 10"/>
          <p:cNvSpPr/>
          <p:nvPr/>
        </p:nvSpPr>
        <p:spPr>
          <a:xfrm>
            <a:off x="4727520" y="1268280"/>
            <a:ext cx="42847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Der Deutsche Hausärzteverband hat gemeinsam mit HausMed internetgestützte Schulungs-Programme für Patienten entwickelt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feld 4"/>
          <p:cNvSpPr/>
          <p:nvPr/>
        </p:nvSpPr>
        <p:spPr>
          <a:xfrm>
            <a:off x="179280" y="4670280"/>
            <a:ext cx="89647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Calibri"/>
                <a:ea typeface="Arial"/>
              </a:rPr>
              <a:t>Mit den HausMed Schulungs-Programmen lernen Sie gesündere Verhaltensweisen – begleitet durch Ihre Hausarztpraxi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hteck 5"/>
          <p:cNvSpPr/>
          <p:nvPr/>
        </p:nvSpPr>
        <p:spPr>
          <a:xfrm>
            <a:off x="4727520" y="2492280"/>
            <a:ext cx="3086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In einem Team au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hteck 6"/>
          <p:cNvSpPr/>
          <p:nvPr/>
        </p:nvSpPr>
        <p:spPr>
          <a:xfrm>
            <a:off x="4992840" y="2878200"/>
            <a:ext cx="3108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3160" indent="-17316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80b5"/>
                </a:solidFill>
                <a:latin typeface="TheSansBold-Plain"/>
                <a:ea typeface="Arial"/>
              </a:rPr>
              <a:t>&gt; 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Ärzt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hteck 7"/>
          <p:cNvSpPr/>
          <p:nvPr/>
        </p:nvSpPr>
        <p:spPr>
          <a:xfrm>
            <a:off x="4992840" y="3224160"/>
            <a:ext cx="3108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3160" indent="-17316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80b5"/>
                </a:solidFill>
                <a:latin typeface="TheSansBold-Plain"/>
                <a:ea typeface="Arial"/>
              </a:rPr>
              <a:t>&gt; 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Psycholog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hteck 9"/>
          <p:cNvSpPr/>
          <p:nvPr/>
        </p:nvSpPr>
        <p:spPr>
          <a:xfrm>
            <a:off x="4992840" y="3583080"/>
            <a:ext cx="317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3160" indent="-17316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80b5"/>
                </a:solidFill>
                <a:latin typeface="TheSansBold-Plain"/>
                <a:ea typeface="Arial"/>
              </a:rPr>
              <a:t>&gt; 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Gesundheitspädagog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hteck 11"/>
          <p:cNvSpPr/>
          <p:nvPr/>
        </p:nvSpPr>
        <p:spPr>
          <a:xfrm>
            <a:off x="4992840" y="3929040"/>
            <a:ext cx="345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3160" indent="-17316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80b5"/>
                </a:solidFill>
                <a:latin typeface="TheSansBold-Plain"/>
                <a:ea typeface="Arial"/>
              </a:rPr>
              <a:t>&gt; 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und Ernährungswissenschaftler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Grafik 12" descr="Untitled-6.jpg"/>
          <p:cNvPicPr/>
          <p:nvPr/>
        </p:nvPicPr>
        <p:blipFill>
          <a:blip r:embed="rId1"/>
          <a:stretch/>
        </p:blipFill>
        <p:spPr>
          <a:xfrm>
            <a:off x="428760" y="1357200"/>
            <a:ext cx="4235400" cy="2987640"/>
          </a:xfrm>
          <a:prstGeom prst="rect">
            <a:avLst/>
          </a:prstGeom>
          <a:ln w="0">
            <a:noFill/>
          </a:ln>
        </p:spPr>
      </p:pic>
    </p:spTree>
  </p:cSld>
  <p:transition spd="slow" advTm="25000">
    <p:wipe dir="l"/>
  </p:transition>
  <p:timing>
    <p:tnLst>
      <p:par>
        <p:cTn id="122" dur="indefinite" restart="never" nodeType="tmRoot">
          <p:childTnLst>
            <p:seq>
              <p:cTn id="123" dur="indefinite" nodeType="mainSeq">
                <p:childTnLst>
                  <p:par>
                    <p:cTn id="124" nodeType="clickEffect" fill="hold">
                      <p:stCondLst>
                        <p:cond delay="0"/>
                      </p:stCondLst>
                      <p:childTnLst>
                        <p:par>
                          <p:cTn id="125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26" nodeType="afterEffect" fill="hold" presetClass="entr" presetID="2" presetSubtype="4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28" dur="2000" fill="hold"/>
                                        <p:tgtEl>
                                          <p:spTgt spid="1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9" dur="2000" fill="hold"/>
                                        <p:tgtEl>
                                          <p:spTgt spid="1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0" nodeType="withEffect" fill="hold" presetClass="entr" presetID="3" presetSubtype="10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132" dur="2000"/>
                                        <p:tgtEl>
                                          <p:spTgt spid="1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3" nodeType="afterEffect" fill="hold">
                            <p:stCondLst>
                              <p:cond delay="4000"/>
                            </p:stCondLst>
                            <p:childTnLst>
                              <p:par>
                                <p:cTn id="134" nodeType="afterEffect" fill="hold" presetClass="entr" presetID="2" presetSubtype="4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6" dur="2000" fill="hold"/>
                                        <p:tgtEl>
                                          <p:spTgt spid="11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37" dur="2000" fill="hold"/>
                                        <p:tgtEl>
                                          <p:spTgt spid="11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8" nodeType="afterEffect" fill="hold">
                            <p:stCondLst>
                              <p:cond delay="8000"/>
                            </p:stCondLst>
                            <p:childTnLst>
                              <p:par>
                                <p:cTn id="139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41" dur="2000" fill="hold"/>
                                        <p:tgtEl>
                                          <p:spTgt spid="11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2" dur="2000" fill="hold"/>
                                        <p:tgtEl>
                                          <p:spTgt spid="11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3" nodeType="afterEffect" fill="hold">
                            <p:stCondLst>
                              <p:cond delay="10500"/>
                            </p:stCondLst>
                            <p:childTnLst>
                              <p:par>
                                <p:cTn id="144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46" dur="2000" fill="hold"/>
                                        <p:tgtEl>
                                          <p:spTgt spid="11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7" dur="2000" fill="hold"/>
                                        <p:tgtEl>
                                          <p:spTgt spid="11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8" nodeType="afterEffect" fill="hold">
                            <p:stCondLst>
                              <p:cond delay="12500"/>
                            </p:stCondLst>
                            <p:childTnLst>
                              <p:par>
                                <p:cTn id="149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1" dur="2000" fill="hold"/>
                                        <p:tgtEl>
                                          <p:spTgt spid="11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52" dur="2000" fill="hold"/>
                                        <p:tgtEl>
                                          <p:spTgt spid="11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3" nodeType="afterEffect" fill="hold">
                            <p:stCondLst>
                              <p:cond delay="14500"/>
                            </p:stCondLst>
                            <p:childTnLst>
                              <p:par>
                                <p:cTn id="154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6" dur="2000" fill="hold"/>
                                        <p:tgtEl>
                                          <p:spTgt spid="11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57" dur="2000" fill="hold"/>
                                        <p:tgtEl>
                                          <p:spTgt spid="11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8" nodeType="afterEffect" fill="hold">
                            <p:stCondLst>
                              <p:cond delay="16500"/>
                            </p:stCondLst>
                            <p:childTnLst>
                              <p:par>
                                <p:cTn id="159" nodeType="afterEffect" fill="hold" presetClass="entr" presetID="2" presetSubtype="4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1" dur="2000" fill="hold"/>
                                        <p:tgtEl>
                                          <p:spTgt spid="11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2" dur="2000" fill="hold"/>
                                        <p:tgtEl>
                                          <p:spTgt spid="11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1" name="Gruppieren 23"/>
          <p:cNvGrpSpPr/>
          <p:nvPr/>
        </p:nvGrpSpPr>
        <p:grpSpPr>
          <a:xfrm>
            <a:off x="428760" y="1165320"/>
            <a:ext cx="8443800" cy="536400"/>
            <a:chOff x="428760" y="1165320"/>
            <a:chExt cx="8443800" cy="536400"/>
          </a:xfrm>
        </p:grpSpPr>
        <p:pic>
          <p:nvPicPr>
            <p:cNvPr id="122" name="Grafik 12" descr=""/>
            <p:cNvPicPr/>
            <p:nvPr/>
          </p:nvPicPr>
          <p:blipFill>
            <a:blip r:embed="rId1"/>
            <a:stretch/>
          </p:blipFill>
          <p:spPr>
            <a:xfrm>
              <a:off x="428760" y="1165320"/>
              <a:ext cx="533160" cy="536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3" name="Textfeld 17"/>
            <p:cNvSpPr/>
            <p:nvPr/>
          </p:nvSpPr>
          <p:spPr>
            <a:xfrm>
              <a:off x="1060920" y="1215000"/>
              <a:ext cx="7811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60812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eichter leben </a:t>
              </a: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0" lang="de-DE" sz="1800" spc="-1" strike="noStrike">
                  <a:solidFill>
                    <a:srgbClr val="0080b5"/>
                  </a:solidFill>
                  <a:latin typeface="TheSansBold-Plain"/>
                  <a:ea typeface="Arial"/>
                </a:rPr>
                <a:t> &gt;</a:t>
              </a:r>
              <a:r>
                <a:rPr b="0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Gesund abnehmen leicht gemacht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4" name="Gruppieren 22"/>
          <p:cNvGrpSpPr/>
          <p:nvPr/>
        </p:nvGrpSpPr>
        <p:grpSpPr>
          <a:xfrm>
            <a:off x="428760" y="2073240"/>
            <a:ext cx="8443800" cy="536760"/>
            <a:chOff x="428760" y="2073240"/>
            <a:chExt cx="8443800" cy="536760"/>
          </a:xfrm>
        </p:grpSpPr>
        <p:pic>
          <p:nvPicPr>
            <p:cNvPr id="125" name="Grafik 13" descr=""/>
            <p:cNvPicPr/>
            <p:nvPr/>
          </p:nvPicPr>
          <p:blipFill>
            <a:blip r:embed="rId2"/>
            <a:stretch/>
          </p:blipFill>
          <p:spPr>
            <a:xfrm>
              <a:off x="428760" y="2073240"/>
              <a:ext cx="533160" cy="536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6" name="Textfeld 18"/>
            <p:cNvSpPr/>
            <p:nvPr/>
          </p:nvSpPr>
          <p:spPr>
            <a:xfrm>
              <a:off x="1060920" y="2118960"/>
              <a:ext cx="7811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60812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auchfrei</a:t>
              </a: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0" lang="de-DE" sz="1800" spc="-1" strike="noStrike">
                  <a:solidFill>
                    <a:srgbClr val="0080b5"/>
                  </a:solidFill>
                  <a:latin typeface="TheSansBold-Plain"/>
                  <a:ea typeface="Arial"/>
                </a:rPr>
                <a:t> &gt; </a:t>
              </a:r>
              <a:r>
                <a:rPr b="0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dlich Nichtraucher werde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7" name="Gruppieren 25"/>
          <p:cNvGrpSpPr/>
          <p:nvPr/>
        </p:nvGrpSpPr>
        <p:grpSpPr>
          <a:xfrm>
            <a:off x="428760" y="3889440"/>
            <a:ext cx="8443800" cy="536400"/>
            <a:chOff x="428760" y="3889440"/>
            <a:chExt cx="8443800" cy="536400"/>
          </a:xfrm>
        </p:grpSpPr>
        <p:pic>
          <p:nvPicPr>
            <p:cNvPr id="128" name="Grafik 14" descr=""/>
            <p:cNvPicPr/>
            <p:nvPr/>
          </p:nvPicPr>
          <p:blipFill>
            <a:blip r:embed="rId3"/>
            <a:stretch/>
          </p:blipFill>
          <p:spPr>
            <a:xfrm>
              <a:off x="428760" y="3889440"/>
              <a:ext cx="533160" cy="536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9" name="Textfeld 19"/>
            <p:cNvSpPr/>
            <p:nvPr/>
          </p:nvSpPr>
          <p:spPr>
            <a:xfrm>
              <a:off x="1060920" y="3952080"/>
              <a:ext cx="7811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60812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luthochdruck </a:t>
              </a: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0" lang="de-DE" sz="1800" spc="-1" strike="noStrike">
                  <a:solidFill>
                    <a:srgbClr val="0080b5"/>
                  </a:solidFill>
                  <a:latin typeface="TheSansBold-Plain"/>
                  <a:ea typeface="Arial"/>
                </a:rPr>
                <a:t> &gt;</a:t>
              </a:r>
              <a:r>
                <a:rPr b="0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Blutdruck senken - Lebensqualität erhöhe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0" name="Gruppieren 26"/>
          <p:cNvGrpSpPr/>
          <p:nvPr/>
        </p:nvGrpSpPr>
        <p:grpSpPr>
          <a:xfrm>
            <a:off x="428760" y="4797360"/>
            <a:ext cx="8443800" cy="536760"/>
            <a:chOff x="428760" y="4797360"/>
            <a:chExt cx="8443800" cy="536760"/>
          </a:xfrm>
        </p:grpSpPr>
        <p:pic>
          <p:nvPicPr>
            <p:cNvPr id="131" name="Grafik 15" descr=""/>
            <p:cNvPicPr/>
            <p:nvPr/>
          </p:nvPicPr>
          <p:blipFill>
            <a:blip r:embed="rId4"/>
            <a:stretch/>
          </p:blipFill>
          <p:spPr>
            <a:xfrm>
              <a:off x="428760" y="4797360"/>
              <a:ext cx="533160" cy="536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2" name="Textfeld 20"/>
            <p:cNvSpPr/>
            <p:nvPr/>
          </p:nvSpPr>
          <p:spPr>
            <a:xfrm>
              <a:off x="1060920" y="4880520"/>
              <a:ext cx="7811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60812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abetes</a:t>
              </a:r>
              <a:r>
                <a:rPr b="0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0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0" lang="de-DE" sz="1800" spc="-1" strike="noStrike">
                  <a:solidFill>
                    <a:srgbClr val="0080b5"/>
                  </a:solidFill>
                  <a:latin typeface="TheSansBold-Plain"/>
                  <a:ea typeface="Arial"/>
                </a:rPr>
                <a:t> &gt;</a:t>
              </a:r>
              <a:r>
                <a:rPr b="0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Leben genießen - mit Diabet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3" name="Gruppieren 24"/>
          <p:cNvGrpSpPr/>
          <p:nvPr/>
        </p:nvGrpSpPr>
        <p:grpSpPr>
          <a:xfrm>
            <a:off x="428760" y="2981160"/>
            <a:ext cx="8443800" cy="536760"/>
            <a:chOff x="428760" y="2981160"/>
            <a:chExt cx="8443800" cy="536760"/>
          </a:xfrm>
        </p:grpSpPr>
        <p:pic>
          <p:nvPicPr>
            <p:cNvPr id="134" name="Grafik 16" descr=""/>
            <p:cNvPicPr/>
            <p:nvPr/>
          </p:nvPicPr>
          <p:blipFill>
            <a:blip r:embed="rId5"/>
            <a:stretch/>
          </p:blipFill>
          <p:spPr>
            <a:xfrm>
              <a:off x="428760" y="2981160"/>
              <a:ext cx="533160" cy="536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5" name="Textfeld 21"/>
            <p:cNvSpPr/>
            <p:nvPr/>
          </p:nvSpPr>
          <p:spPr>
            <a:xfrm>
              <a:off x="1060920" y="3035520"/>
              <a:ext cx="7811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60812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tressfrei </a:t>
              </a: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1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	</a:t>
              </a:r>
              <a:r>
                <a:rPr b="0" lang="de-DE" sz="1800" spc="-1" strike="noStrike">
                  <a:solidFill>
                    <a:srgbClr val="0080b5"/>
                  </a:solidFill>
                  <a:latin typeface="TheSansBold-Plain"/>
                  <a:ea typeface="Arial"/>
                </a:rPr>
                <a:t> &gt; </a:t>
              </a:r>
              <a:r>
                <a:rPr b="0" lang="de-DE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tress verstehen, Stress abbaue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6" name="Rectangle 2"/>
          <p:cNvSpPr/>
          <p:nvPr/>
        </p:nvSpPr>
        <p:spPr>
          <a:xfrm>
            <a:off x="395280" y="287280"/>
            <a:ext cx="8255160" cy="80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Calibri"/>
              </a:rPr>
              <a:t>Welche Schulungs-Programme gibt es?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 advTm="23000">
    <p:wipe dir="l"/>
  </p:transition>
  <p:timing>
    <p:tnLst>
      <p:par>
        <p:cTn id="163" dur="indefinite" restart="never" nodeType="tmRoot">
          <p:childTnLst>
            <p:seq>
              <p:cTn id="164" dur="indefinite" nodeType="mainSeq">
                <p:childTnLst>
                  <p:par>
                    <p:cTn id="165" nodeType="clickEffect" fill="hold">
                      <p:stCondLst>
                        <p:cond delay="0"/>
                      </p:stCondLst>
                      <p:childTnLst>
                        <p:par>
                          <p:cTn id="166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67" nodeType="afterEffect" fill="hold" presetClass="entr" presetID="2" presetSubtype="4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9" dur="3000" fill="hold"/>
                                        <p:tgtEl>
                                          <p:spTgt spid="12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0" dur="3000" fill="hold"/>
                                        <p:tgtEl>
                                          <p:spTgt spid="12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1" nodeType="afterEffect" fill="hold">
                            <p:stCondLst>
                              <p:cond delay="5000"/>
                            </p:stCondLst>
                            <p:childTnLst>
                              <p:par>
                                <p:cTn id="172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74" dur="3000" fill="hold"/>
                                        <p:tgtEl>
                                          <p:spTgt spid="12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5" dur="3000" fill="hold"/>
                                        <p:tgtEl>
                                          <p:spTgt spid="12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6" nodeType="afterEffect" fill="hold">
                            <p:stCondLst>
                              <p:cond delay="8500"/>
                            </p:stCondLst>
                            <p:childTnLst>
                              <p:par>
                                <p:cTn id="177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79" dur="3000" fill="hold"/>
                                        <p:tgtEl>
                                          <p:spTgt spid="13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80" dur="3000" fill="hold"/>
                                        <p:tgtEl>
                                          <p:spTgt spid="13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1" nodeType="afterEffect" fill="hold">
                            <p:stCondLst>
                              <p:cond delay="12000"/>
                            </p:stCondLst>
                            <p:childTnLst>
                              <p:par>
                                <p:cTn id="182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84" dur="3000" fill="hold"/>
                                        <p:tgtEl>
                                          <p:spTgt spid="12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85" dur="3000" fill="hold"/>
                                        <p:tgtEl>
                                          <p:spTgt spid="12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6" nodeType="afterEffect" fill="hold">
                            <p:stCondLst>
                              <p:cond delay="15500"/>
                            </p:stCondLst>
                            <p:childTnLst>
                              <p:par>
                                <p:cTn id="187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1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89" dur="3000" fill="hold"/>
                                        <p:tgtEl>
                                          <p:spTgt spid="13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90" dur="3000" fill="hold"/>
                                        <p:tgtEl>
                                          <p:spTgt spid="13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Rectangle 2"/>
          <p:cNvSpPr/>
          <p:nvPr/>
        </p:nvSpPr>
        <p:spPr>
          <a:xfrm>
            <a:off x="395280" y="287280"/>
            <a:ext cx="8255160" cy="80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Calibri"/>
              </a:rPr>
              <a:t>Die HausMed Schulungs-Programm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hteck 35"/>
          <p:cNvSpPr/>
          <p:nvPr/>
        </p:nvSpPr>
        <p:spPr>
          <a:xfrm>
            <a:off x="260280" y="836640"/>
            <a:ext cx="1579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Calibri"/>
                <a:ea typeface="Arial"/>
              </a:rPr>
              <a:t>Das Prinzip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hteck 37"/>
          <p:cNvSpPr/>
          <p:nvPr/>
        </p:nvSpPr>
        <p:spPr>
          <a:xfrm>
            <a:off x="261720" y="3043080"/>
            <a:ext cx="2872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Calibri"/>
                <a:ea typeface="Arial"/>
              </a:rPr>
              <a:t>Das Besondere dara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Gruppieren 23"/>
          <p:cNvGrpSpPr/>
          <p:nvPr/>
        </p:nvGrpSpPr>
        <p:grpSpPr>
          <a:xfrm>
            <a:off x="6516720" y="1125360"/>
            <a:ext cx="1727280" cy="2132280"/>
            <a:chOff x="6516720" y="1125360"/>
            <a:chExt cx="1727280" cy="2132280"/>
          </a:xfrm>
        </p:grpSpPr>
        <p:sp>
          <p:nvSpPr>
            <p:cNvPr id="141" name="Rechteck 38"/>
            <p:cNvSpPr/>
            <p:nvPr/>
          </p:nvSpPr>
          <p:spPr>
            <a:xfrm>
              <a:off x="6516720" y="1125360"/>
              <a:ext cx="1727280" cy="2132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marL="182520" indent="-92160">
                <a:lnSpc>
                  <a:spcPct val="100000"/>
                </a:lnSpc>
                <a:buClr>
                  <a:srgbClr val="000000"/>
                </a:buClr>
                <a:buFont typeface="Arial"/>
                <a:buChar char="•"/>
                <a:tabLst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2" name="Picture 4" descr=""/>
            <p:cNvPicPr/>
            <p:nvPr/>
          </p:nvPicPr>
          <p:blipFill>
            <a:blip r:embed="rId1"/>
            <a:srcRect l="28966" t="9929" r="28921" b="8119"/>
            <a:stretch/>
          </p:blipFill>
          <p:spPr>
            <a:xfrm>
              <a:off x="6532200" y="1132200"/>
              <a:ext cx="1702440" cy="21182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43" name="Gruppieren 24"/>
          <p:cNvGrpSpPr/>
          <p:nvPr/>
        </p:nvGrpSpPr>
        <p:grpSpPr>
          <a:xfrm>
            <a:off x="7093080" y="2544840"/>
            <a:ext cx="1674720" cy="2252520"/>
            <a:chOff x="7093080" y="2544840"/>
            <a:chExt cx="1674720" cy="2252520"/>
          </a:xfrm>
        </p:grpSpPr>
        <p:pic>
          <p:nvPicPr>
            <p:cNvPr id="144" name="Picture 3" descr=""/>
            <p:cNvPicPr/>
            <p:nvPr/>
          </p:nvPicPr>
          <p:blipFill>
            <a:blip r:embed="rId2"/>
            <a:srcRect l="14940" t="0" r="11395" b="2877"/>
            <a:stretch/>
          </p:blipFill>
          <p:spPr>
            <a:xfrm>
              <a:off x="7093800" y="2552040"/>
              <a:ext cx="1667880" cy="2235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5" name="Rechteck 45"/>
            <p:cNvSpPr/>
            <p:nvPr/>
          </p:nvSpPr>
          <p:spPr>
            <a:xfrm>
              <a:off x="7093080" y="2544840"/>
              <a:ext cx="1674720" cy="2252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marL="182520" indent="-92160">
                <a:lnSpc>
                  <a:spcPct val="100000"/>
                </a:lnSpc>
                <a:buClr>
                  <a:srgbClr val="000000"/>
                </a:buClr>
                <a:buFont typeface="Arial"/>
                <a:buChar char="•"/>
                <a:tabLst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6" name="Abgerundetes Rechteck 12"/>
          <p:cNvSpPr/>
          <p:nvPr/>
        </p:nvSpPr>
        <p:spPr>
          <a:xfrm>
            <a:off x="214200" y="1284120"/>
            <a:ext cx="5942160" cy="1714680"/>
          </a:xfrm>
          <a:prstGeom prst="roundRect">
            <a:avLst>
              <a:gd name="adj" fmla="val 16667"/>
            </a:avLst>
          </a:prstGeom>
          <a:solidFill>
            <a:srgbClr val="ddd2a4"/>
          </a:solidFill>
          <a:ln w="25560">
            <a:solidFill>
              <a:srgbClr val="e5dbb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marL="268200" indent="-2682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Abgerundetes Rechteck 13"/>
          <p:cNvSpPr/>
          <p:nvPr/>
        </p:nvSpPr>
        <p:spPr>
          <a:xfrm>
            <a:off x="214200" y="3498840"/>
            <a:ext cx="5942160" cy="2071800"/>
          </a:xfrm>
          <a:prstGeom prst="roundRect">
            <a:avLst>
              <a:gd name="adj" fmla="val 16667"/>
            </a:avLst>
          </a:prstGeom>
          <a:solidFill>
            <a:srgbClr val="ddd2a4"/>
          </a:solidFill>
          <a:ln w="25560">
            <a:solidFill>
              <a:srgbClr val="e5dbb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marL="268200" indent="-2682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8" name="Grafik 14" descr="ihf.png"/>
          <p:cNvPicPr/>
          <p:nvPr/>
        </p:nvPicPr>
        <p:blipFill>
          <a:blip r:embed="rId3"/>
          <a:stretch/>
        </p:blipFill>
        <p:spPr>
          <a:xfrm rot="178800">
            <a:off x="5416560" y="4610160"/>
            <a:ext cx="1143000" cy="1130400"/>
          </a:xfrm>
          <a:prstGeom prst="rect">
            <a:avLst/>
          </a:prstGeom>
          <a:ln w="0">
            <a:noFill/>
          </a:ln>
        </p:spPr>
      </p:pic>
      <p:sp>
        <p:nvSpPr>
          <p:cNvPr id="149" name="Rechteck 15"/>
          <p:cNvSpPr/>
          <p:nvPr/>
        </p:nvSpPr>
        <p:spPr>
          <a:xfrm>
            <a:off x="360360" y="2517840"/>
            <a:ext cx="529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64960" indent="-26496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AutoNum type="arabicParenR" startAt="4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Dauer: 12 Wochen – für nur rund 1,- EUR/Ta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hteck 16"/>
          <p:cNvSpPr/>
          <p:nvPr/>
        </p:nvSpPr>
        <p:spPr>
          <a:xfrm>
            <a:off x="360360" y="1422360"/>
            <a:ext cx="457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64960" indent="-26496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AutoNum type="arabi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Nachhaltige Verhaltensänderunge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hteck 17"/>
          <p:cNvSpPr/>
          <p:nvPr/>
        </p:nvSpPr>
        <p:spPr>
          <a:xfrm>
            <a:off x="360360" y="1787400"/>
            <a:ext cx="457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64960" indent="-26496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AutoNum type="arabicParenR" startAt="2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Keine radikale Lebensstilumstellu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hteck 18"/>
          <p:cNvSpPr/>
          <p:nvPr/>
        </p:nvSpPr>
        <p:spPr>
          <a:xfrm>
            <a:off x="404280" y="2152800"/>
            <a:ext cx="3190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264960" indent="-26496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AutoNum type="arabicParenR" startAt="3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Vermeidung des Jojo-Effekt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hteck 19"/>
          <p:cNvSpPr/>
          <p:nvPr/>
        </p:nvSpPr>
        <p:spPr>
          <a:xfrm>
            <a:off x="360360" y="3645000"/>
            <a:ext cx="543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68200" indent="-2682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AutoNum type="arabi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Online, aber mit aktiver Begleitung des Hausarz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hteck 20"/>
          <p:cNvSpPr/>
          <p:nvPr/>
        </p:nvSpPr>
        <p:spPr>
          <a:xfrm>
            <a:off x="360360" y="4029120"/>
            <a:ext cx="543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68200" indent="-26820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AutoNum type="arabicParenR" startAt="2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Auf Patientenbedürfnisse individuell angepas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hteck 22"/>
          <p:cNvSpPr/>
          <p:nvPr/>
        </p:nvSpPr>
        <p:spPr>
          <a:xfrm>
            <a:off x="360360" y="5075280"/>
            <a:ext cx="457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64960" indent="-26496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AutoNum type="arabicParenR" startAt="4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Garantierte Qualität durch IhF-Zertifika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hteck 25"/>
          <p:cNvSpPr/>
          <p:nvPr/>
        </p:nvSpPr>
        <p:spPr>
          <a:xfrm>
            <a:off x="360360" y="4414680"/>
            <a:ext cx="5435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64960" indent="-264960">
              <a:lnSpc>
                <a:spcPct val="100000"/>
              </a:lnSpc>
              <a:spcBef>
                <a:spcPts val="601"/>
              </a:spcBef>
              <a:buClr>
                <a:srgbClr val="000000"/>
              </a:buClr>
              <a:buFont typeface="Calibri"/>
              <a:buAutoNum type="arabicParenR" startAt="3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  <a:ea typeface="Arial"/>
              </a:rPr>
              <a:t>Kostenerstattung durch verschiedene Krankenkassen bei Präventionskursen möglic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 advTm="40000">
    <p:wipe dir="l"/>
  </p:transition>
  <p:timing>
    <p:tnLst>
      <p:par>
        <p:cTn id="191" dur="indefinite" restart="never" nodeType="tmRoot">
          <p:childTnLst>
            <p:seq>
              <p:cTn id="192" dur="indefinite" nodeType="mainSeq">
                <p:childTnLst>
                  <p:par>
                    <p:cTn id="193" nodeType="clickEffect" fill="hold">
                      <p:stCondLst>
                        <p:cond delay="0"/>
                      </p:stCondLst>
                      <p:childTnLst>
                        <p:par>
                          <p:cTn id="19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95" nodeType="afterEffect" fill="hold" presetClass="entr" presetID="5" presetSubtype="5">
                                  <p:stCondLst>
                                    <p:cond delay="1500"/>
                                  </p:stCondLst>
                                  <p:childTnLst>
                                    <p:set>
                                      <p:cBhvr>
                                        <p:cTn id="1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checkerboard(down)" transition="in">
                                      <p:cBhvr additive="repl">
                                        <p:cTn id="197" dur="2000"/>
                                        <p:tgtEl>
                                          <p:spTgt spid="14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98" nodeType="withEffect" fill="hold" presetClass="entr" presetID="5" presetSubtype="5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checkerboard(down)" transition="in">
                                      <p:cBhvr additive="repl">
                                        <p:cTn id="200" dur="2000"/>
                                        <p:tgtEl>
                                          <p:spTgt spid="14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1" nodeType="with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03" dur="3000" fill="hold"/>
                                        <p:tgtEl>
                                          <p:spTgt spid="13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4" dur="3000" fill="hold"/>
                                        <p:tgtEl>
                                          <p:spTgt spid="13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05" nodeType="with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07" dur="3000" fill="hold"/>
                                        <p:tgtEl>
                                          <p:spTgt spid="14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8" dur="3000" fill="hold"/>
                                        <p:tgtEl>
                                          <p:spTgt spid="14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9" nodeType="afterEffect" fill="hold">
                            <p:stCondLst>
                              <p:cond delay="3500"/>
                            </p:stCondLst>
                            <p:childTnLst>
                              <p:par>
                                <p:cTn id="210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12" dur="3000" fill="hold"/>
                                        <p:tgtEl>
                                          <p:spTgt spid="15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13" dur="3000" fill="hold"/>
                                        <p:tgtEl>
                                          <p:spTgt spid="15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4" nodeType="afterEffect" fill="hold">
                            <p:stCondLst>
                              <p:cond delay="7000"/>
                            </p:stCondLst>
                            <p:childTnLst>
                              <p:par>
                                <p:cTn id="215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17" dur="3000" fill="hold"/>
                                        <p:tgtEl>
                                          <p:spTgt spid="15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18" dur="3000" fill="hold"/>
                                        <p:tgtEl>
                                          <p:spTgt spid="15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9" nodeType="afterEffect" fill="hold">
                            <p:stCondLst>
                              <p:cond delay="10500"/>
                            </p:stCondLst>
                            <p:childTnLst>
                              <p:par>
                                <p:cTn id="220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22" dur="3000" fill="hold"/>
                                        <p:tgtEl>
                                          <p:spTgt spid="15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23" dur="3000" fill="hold"/>
                                        <p:tgtEl>
                                          <p:spTgt spid="15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4" nodeType="afterEffect" fill="hold">
                            <p:stCondLst>
                              <p:cond delay="14000"/>
                            </p:stCondLst>
                            <p:childTnLst>
                              <p:par>
                                <p:cTn id="225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27" dur="3000" fill="hold"/>
                                        <p:tgtEl>
                                          <p:spTgt spid="14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28" dur="3000" fill="hold"/>
                                        <p:tgtEl>
                                          <p:spTgt spid="14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9" nodeType="afterEffect" fill="hold">
                            <p:stCondLst>
                              <p:cond delay="17000"/>
                            </p:stCondLst>
                            <p:childTnLst>
                              <p:par>
                                <p:cTn id="230" nodeType="afterEffect" fill="hold" presetClass="entr" presetID="2" presetSubtype="4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2" dur="3000" fill="hold"/>
                                        <p:tgtEl>
                                          <p:spTgt spid="13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33" dur="3000" fill="hold"/>
                                        <p:tgtEl>
                                          <p:spTgt spid="13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34" nodeType="withEffect" fill="hold" presetClass="entr" presetID="2" presetSubtype="4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6" dur="3000" fill="hold"/>
                                        <p:tgtEl>
                                          <p:spTgt spid="14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37" dur="3000" fill="hold"/>
                                        <p:tgtEl>
                                          <p:spTgt spid="14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38" nodeType="afterEffect" fill="hold">
                            <p:stCondLst>
                              <p:cond delay="21000"/>
                            </p:stCondLst>
                            <p:childTnLst>
                              <p:par>
                                <p:cTn id="239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41" dur="3000" fill="hold"/>
                                        <p:tgtEl>
                                          <p:spTgt spid="15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2" dur="3000" fill="hold"/>
                                        <p:tgtEl>
                                          <p:spTgt spid="15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3" nodeType="afterEffect" fill="hold">
                            <p:stCondLst>
                              <p:cond delay="24500"/>
                            </p:stCondLst>
                            <p:childTnLst>
                              <p:par>
                                <p:cTn id="244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46" dur="3000" fill="hold"/>
                                        <p:tgtEl>
                                          <p:spTgt spid="15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7" dur="3000" fill="hold"/>
                                        <p:tgtEl>
                                          <p:spTgt spid="15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8" nodeType="afterEffect" fill="hold">
                            <p:stCondLst>
                              <p:cond delay="28000"/>
                            </p:stCondLst>
                            <p:childTnLst>
                              <p:par>
                                <p:cTn id="249" nodeType="afterEffect" fill="hold" presetClass="entr" presetID="2" presetSubtype="4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1" dur="3000" fill="hold"/>
                                        <p:tgtEl>
                                          <p:spTgt spid="15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52" dur="3000" fill="hold"/>
                                        <p:tgtEl>
                                          <p:spTgt spid="15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3" nodeType="afterEffect" fill="hold">
                            <p:stCondLst>
                              <p:cond delay="31000"/>
                            </p:stCondLst>
                            <p:childTnLst>
                              <p:par>
                                <p:cTn id="254" nodeType="afterEffect" fill="hold" presetClass="entr" presetID="2" presetSubtype="4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25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6" dur="3000" fill="hold"/>
                                        <p:tgtEl>
                                          <p:spTgt spid="15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57" dur="3000" fill="hold"/>
                                        <p:tgtEl>
                                          <p:spTgt spid="15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8" nodeType="afterEffect" fill="hold">
                            <p:stCondLst>
                              <p:cond delay="34500"/>
                            </p:stCondLst>
                            <p:childTnLst>
                              <p:par>
                                <p:cTn id="259" nodeType="afterEffect" fill="hold" presetClass="entr" presetID="5" presetSubtype="5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checkerboard(down)" transition="in">
                                      <p:cBhvr additive="repl">
                                        <p:cTn id="261" dur="2000"/>
                                        <p:tgtEl>
                                          <p:spTgt spid="14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2" nodeType="afterEffect" fill="hold">
                            <p:stCondLst>
                              <p:cond delay="36500"/>
                            </p:stCondLst>
                            <p:childTnLst>
                              <p:par>
                                <p:cTn id="263" nodeType="afterEffect" fill="hold" presetClass="emph" presetID="8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64" dur="2000" fill="hold"/>
                                        <p:tgtEl>
                                          <p:spTgt spid="14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Rectangle 2"/>
          <p:cNvSpPr/>
          <p:nvPr/>
        </p:nvSpPr>
        <p:spPr>
          <a:xfrm>
            <a:off x="468360" y="549360"/>
            <a:ext cx="8254800" cy="22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ctr">
              <a:lnSpc>
                <a:spcPct val="100000"/>
              </a:lnSpc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3200" spc="-1" strike="noStrike">
                <a:solidFill>
                  <a:srgbClr val="000000"/>
                </a:solidFill>
                <a:latin typeface="Calibri"/>
              </a:rPr>
              <a:t>Senken Sie Ihr persönliches Risiko!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hteck 2"/>
          <p:cNvSpPr/>
          <p:nvPr/>
        </p:nvSpPr>
        <p:spPr>
          <a:xfrm>
            <a:off x="1692360" y="3029040"/>
            <a:ext cx="5759280" cy="109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Calibri"/>
              </a:rPr>
              <a:t>Sprechen Sie unser Praxisteam 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601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800" spc="-1" strike="noStrike">
                <a:solidFill>
                  <a:srgbClr val="000000"/>
                </a:solidFill>
                <a:latin typeface="Calibri"/>
              </a:rPr>
              <a:t>auf die Schulungs-Programme an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 advTm="20000">
    <p:wipe dir="l"/>
  </p:transition>
  <p:timing>
    <p:tnLst>
      <p:par>
        <p:cTn id="265" dur="indefinite" restart="never" nodeType="tmRoot">
          <p:childTnLst>
            <p:seq>
              <p:cTn id="266" dur="indefinite" nodeType="mainSeq">
                <p:childTnLst>
                  <p:par>
                    <p:cTn id="267" nodeType="clickEffect" fill="hold">
                      <p:stCondLst>
                        <p:cond delay="0"/>
                      </p:stCondLst>
                      <p:childTnLst>
                        <p:par>
                          <p:cTn id="268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269" nodeType="afterEffect" fill="hold" presetClass="entr" presetID="3" presetSubtype="10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2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271" dur="2000"/>
                                        <p:tgtEl>
                                          <p:spTgt spid="15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16T09:25:18Z</dcterms:created>
  <dc:creator>Jasper Blome</dc:creator>
  <dc:description/>
  <dc:language>en-US</dc:language>
  <cp:lastModifiedBy>mehring</cp:lastModifiedBy>
  <dcterms:modified xsi:type="dcterms:W3CDTF">2014-05-13T10:37:21Z</dcterms:modified>
  <cp:revision>161</cp:revision>
  <dc:subject/>
  <dc:title>Folie 1</dc:title>
</cp:coreProperties>
</file>